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Default Extension="png" ContentType="image/png"/>
  <Override PartName="/ppt/slideLayouts/slideLayout7.xml" ContentType="application/vnd.openxmlformats-officedocument.presentationml.slideLayout+xml"/>
  <Override PartName="/ppt/charts/style1.xml" ContentType="application/vnd.ms-office.chartstyl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Default Extension="emf" ContentType="image/x-emf"/>
  <Default Extension="jpeg" ContentType="image/jpeg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0" r:id="rId2"/>
    <p:sldId id="265" r:id="rId3"/>
    <p:sldId id="275" r:id="rId4"/>
  </p:sldIdLst>
  <p:sldSz cx="6858000" cy="9144000" type="screen4x3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raaca" initials="h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246" autoAdjust="0"/>
    <p:restoredTop sz="94660"/>
  </p:normalViewPr>
  <p:slideViewPr>
    <p:cSldViewPr snapToGrid="0">
      <p:cViewPr>
        <p:scale>
          <a:sx n="100" d="100"/>
          <a:sy n="100" d="100"/>
        </p:scale>
        <p:origin x="1300" y="-8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openxmlformats.org/officeDocument/2006/relationships/customXml" Target="../customXml/item3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openxmlformats.org/officeDocument/2006/relationships/customXml" Target="../customXml/item2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11" Type="http://schemas.openxmlformats.org/officeDocument/2006/relationships/customXml" Target="../customXml/item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Akldfs12\home$\HRACXB\MY%20DOCUMENTS\Redstuff\data\R6%20paper\New%20Figures\transient%20data%20for%20figure%20F35H%20in%20benth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Akldfs12\home$\HRACXB\MY%20DOCUMENTS\Redstuff\data\R6%20paper\New%20Figures\transient%20data%20for%20figure%20F35H%20in%20benth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Akldfs12\home$\HRACXB\MY%20DOCUMENTS\Redstuff\data\R6%20paper\New%20Figures\Btransient%20data%20for%20figure%20F35H%20in%20benth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Akldfs12\home$\HRACXB\MY%20DOCUMENTS\Redstuff\data\R6%20paper\New%20Figures\transient%20data%20for%20figure%20F35H%20in%20bent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Akldfs12\home$\HRACXB\MY%20DOCUMENTS\Redstuff\data\R6%20paper\New%20Figures\transient%20data%20for%20figure%20F35H%20in%20benth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Akldfs12\home$\HRACXB\MY%20DOCUMENTS\Redstuff\data\R6%20paper\New%20Figures\transient%20data%20for%20figure%20F35H%20in%20bent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844513919479123"/>
          <c:y val="5.1400554097404488E-2"/>
          <c:w val="0.6894255656244126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UC-REN in benth'!$C$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LUC-REN in benth'!$D$5:$D$6</c:f>
                <c:numCache>
                  <c:formatCode>General</c:formatCode>
                  <c:ptCount val="2"/>
                  <c:pt idx="0">
                    <c:v>6.0669414356585502E-2</c:v>
                  </c:pt>
                  <c:pt idx="1">
                    <c:v>0.31827171610071464</c:v>
                  </c:pt>
                </c:numCache>
              </c:numRef>
            </c:plus>
            <c:minus>
              <c:numRef>
                <c:f>'LUC-REN in benth'!$D$5:$D$6</c:f>
                <c:numCache>
                  <c:formatCode>General</c:formatCode>
                  <c:ptCount val="2"/>
                  <c:pt idx="0">
                    <c:v>6.0669414356585502E-2</c:v>
                  </c:pt>
                  <c:pt idx="1">
                    <c:v>0.31827171610071464</c:v>
                  </c:pt>
                </c:numCache>
              </c:numRef>
            </c:minus>
          </c:errBars>
          <c:cat>
            <c:strRef>
              <c:f>'LUC-REN in benth'!$B$5:$B$6</c:f>
              <c:strCache>
                <c:ptCount val="2"/>
                <c:pt idx="0">
                  <c:v>no TF</c:v>
                </c:pt>
                <c:pt idx="1">
                  <c:v>AcMYB110</c:v>
                </c:pt>
              </c:strCache>
            </c:strRef>
          </c:cat>
          <c:val>
            <c:numRef>
              <c:f>'LUC-REN in benth'!$C$5:$C$6</c:f>
              <c:numCache>
                <c:formatCode>0.00</c:formatCode>
                <c:ptCount val="2"/>
                <c:pt idx="0">
                  <c:v>0.73685579021746261</c:v>
                </c:pt>
                <c:pt idx="1">
                  <c:v>2.5344673678111289</c:v>
                </c:pt>
              </c:numCache>
            </c:numRef>
          </c:val>
        </c:ser>
        <c:ser>
          <c:idx val="1"/>
          <c:order val="1"/>
          <c:tx>
            <c:strRef>
              <c:f>'LUC-REN in benth'!$E$4</c:f>
              <c:strCache>
                <c:ptCount val="1"/>
                <c:pt idx="0">
                  <c:v>R6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LUC-REN in benth'!$F$5:$F$6</c:f>
                <c:numCache>
                  <c:formatCode>General</c:formatCode>
                  <c:ptCount val="2"/>
                  <c:pt idx="0">
                    <c:v>3.7536935813524221E-2</c:v>
                  </c:pt>
                  <c:pt idx="1">
                    <c:v>0.49405837354167725</c:v>
                  </c:pt>
                </c:numCache>
              </c:numRef>
            </c:plus>
            <c:minus>
              <c:numRef>
                <c:f>'LUC-REN in benth'!$F$5:$F$6</c:f>
                <c:numCache>
                  <c:formatCode>General</c:formatCode>
                  <c:ptCount val="2"/>
                  <c:pt idx="0">
                    <c:v>3.7536935813524221E-2</c:v>
                  </c:pt>
                  <c:pt idx="1">
                    <c:v>0.49405837354167725</c:v>
                  </c:pt>
                </c:numCache>
              </c:numRef>
            </c:minus>
          </c:errBars>
          <c:val>
            <c:numRef>
              <c:f>'LUC-REN in benth'!$E$5:$E$6</c:f>
              <c:numCache>
                <c:formatCode>0.00</c:formatCode>
                <c:ptCount val="2"/>
                <c:pt idx="0">
                  <c:v>0.73657537281294583</c:v>
                </c:pt>
                <c:pt idx="1">
                  <c:v>9.06004924144344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4472056"/>
        <c:axId val="424472448"/>
      </c:barChart>
      <c:catAx>
        <c:axId val="4244720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24472448"/>
        <c:crosses val="autoZero"/>
        <c:auto val="1"/>
        <c:lblAlgn val="ctr"/>
        <c:lblOffset val="100"/>
        <c:noMultiLvlLbl val="0"/>
      </c:catAx>
      <c:valAx>
        <c:axId val="424472448"/>
        <c:scaling>
          <c:orientation val="minMax"/>
          <c:max val="15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crossAx val="424472056"/>
        <c:crosses val="autoZero"/>
        <c:crossBetween val="between"/>
        <c:majorUnit val="4"/>
      </c:valAx>
    </c:plotArea>
    <c:legend>
      <c:legendPos val="r"/>
      <c:layout>
        <c:manualLayout>
          <c:xMode val="edge"/>
          <c:yMode val="edge"/>
          <c:x val="0.16766867515920936"/>
          <c:y val="0.17561951301891277"/>
          <c:w val="0.18892017151736115"/>
          <c:h val="0.14119203849518824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46971462913194"/>
          <c:y val="5.1400554097404488E-2"/>
          <c:w val="0.73389431925182669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UC-REN in benth'!$C$2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LUC-REN in benth'!$D$22:$D$23</c:f>
                <c:numCache>
                  <c:formatCode>General</c:formatCode>
                  <c:ptCount val="2"/>
                  <c:pt idx="0">
                    <c:v>4.3459166226532113E-2</c:v>
                  </c:pt>
                  <c:pt idx="1">
                    <c:v>0.23500567033670203</c:v>
                  </c:pt>
                </c:numCache>
              </c:numRef>
            </c:plus>
            <c:minus>
              <c:numRef>
                <c:f>'LUC-REN in benth'!$D$22:$D$23</c:f>
                <c:numCache>
                  <c:formatCode>General</c:formatCode>
                  <c:ptCount val="2"/>
                  <c:pt idx="0">
                    <c:v>4.3459166226532113E-2</c:v>
                  </c:pt>
                  <c:pt idx="1">
                    <c:v>0.23500567033670203</c:v>
                  </c:pt>
                </c:numCache>
              </c:numRef>
            </c:minus>
          </c:errBars>
          <c:cat>
            <c:strRef>
              <c:f>'LUC-REN in benth'!$B$22:$B$23</c:f>
              <c:strCache>
                <c:ptCount val="2"/>
                <c:pt idx="0">
                  <c:v>no TF</c:v>
                </c:pt>
                <c:pt idx="1">
                  <c:v>MdMYB10+bHLH3</c:v>
                </c:pt>
              </c:strCache>
            </c:strRef>
          </c:cat>
          <c:val>
            <c:numRef>
              <c:f>'LUC-REN in benth'!$C$22:$C$23</c:f>
              <c:numCache>
                <c:formatCode>0.00</c:formatCode>
                <c:ptCount val="2"/>
                <c:pt idx="0">
                  <c:v>0.75570774592658096</c:v>
                </c:pt>
                <c:pt idx="1">
                  <c:v>4.0560547290599782</c:v>
                </c:pt>
              </c:numCache>
            </c:numRef>
          </c:val>
        </c:ser>
        <c:ser>
          <c:idx val="1"/>
          <c:order val="1"/>
          <c:tx>
            <c:strRef>
              <c:f>'LUC-REN in benth'!$E$21</c:f>
              <c:strCache>
                <c:ptCount val="1"/>
                <c:pt idx="0">
                  <c:v>R6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LUC-REN in benth'!$F$22:$F$23</c:f>
                <c:numCache>
                  <c:formatCode>General</c:formatCode>
                  <c:ptCount val="2"/>
                  <c:pt idx="0">
                    <c:v>0.17191289121805955</c:v>
                  </c:pt>
                  <c:pt idx="1">
                    <c:v>0.70656577367836604</c:v>
                  </c:pt>
                </c:numCache>
              </c:numRef>
            </c:plus>
            <c:minus>
              <c:numRef>
                <c:f>'LUC-REN in benth'!$F$22:$F$23</c:f>
                <c:numCache>
                  <c:formatCode>General</c:formatCode>
                  <c:ptCount val="2"/>
                  <c:pt idx="0">
                    <c:v>0.17191289121805955</c:v>
                  </c:pt>
                  <c:pt idx="1">
                    <c:v>0.70656577367836604</c:v>
                  </c:pt>
                </c:numCache>
              </c:numRef>
            </c:minus>
          </c:errBars>
          <c:val>
            <c:numRef>
              <c:f>'LUC-REN in benth'!$E$22:$E$23</c:f>
              <c:numCache>
                <c:formatCode>0.00</c:formatCode>
                <c:ptCount val="2"/>
                <c:pt idx="0">
                  <c:v>0.77161859722103643</c:v>
                </c:pt>
                <c:pt idx="1">
                  <c:v>13.0608832044579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4473232"/>
        <c:axId val="424473624"/>
      </c:barChart>
      <c:catAx>
        <c:axId val="424473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24473624"/>
        <c:crosses val="autoZero"/>
        <c:auto val="1"/>
        <c:lblAlgn val="ctr"/>
        <c:lblOffset val="100"/>
        <c:noMultiLvlLbl val="0"/>
      </c:catAx>
      <c:valAx>
        <c:axId val="424473624"/>
        <c:scaling>
          <c:orientation val="minMax"/>
          <c:max val="15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NZ"/>
                  <a:t>LUC/REN ratio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424473232"/>
        <c:crosses val="autoZero"/>
        <c:crossBetween val="between"/>
        <c:majorUnit val="4"/>
      </c:valAx>
    </c:plotArea>
    <c:legend>
      <c:legendPos val="r"/>
      <c:layout>
        <c:manualLayout>
          <c:xMode val="edge"/>
          <c:yMode val="edge"/>
          <c:x val="0.22994770691831459"/>
          <c:y val="0.15702354913969091"/>
          <c:w val="0.22280970716175938"/>
          <c:h val="0.17146152408182835"/>
        </c:manualLayout>
      </c:layout>
      <c:overlay val="0"/>
    </c:legend>
    <c:plotVisOnly val="1"/>
    <c:dispBlanksAs val="gap"/>
    <c:showDLblsOverMax val="0"/>
  </c:chart>
  <c:spPr>
    <a:solidFill>
      <a:schemeClr val="bg1"/>
    </a:solidFill>
    <a:ln>
      <a:noFill/>
    </a:ln>
  </c:spPr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50613464616622"/>
          <c:y val="4.5409078466418687E-2"/>
          <c:w val="0.8094212791247658"/>
          <c:h val="0.666493728161280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ntho in Nt'!$K$18</c:f>
              <c:strCache>
                <c:ptCount val="1"/>
                <c:pt idx="0">
                  <c:v>Dp/Cy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ntho in Nt'!$L$19:$L$22</c:f>
                <c:numCache>
                  <c:formatCode>General</c:formatCode>
                  <c:ptCount val="4"/>
                  <c:pt idx="0">
                    <c:v>7.4072043988188924E-2</c:v>
                  </c:pt>
                  <c:pt idx="1">
                    <c:v>8.2163114506014989E-2</c:v>
                  </c:pt>
                  <c:pt idx="2">
                    <c:v>1.8550025363635829</c:v>
                  </c:pt>
                  <c:pt idx="3">
                    <c:v>0.42476562949596242</c:v>
                  </c:pt>
                </c:numCache>
              </c:numRef>
            </c:plus>
            <c:minus>
              <c:numRef>
                <c:f>'Antho in Nt'!$L$19:$L$22</c:f>
                <c:numCache>
                  <c:formatCode>General</c:formatCode>
                  <c:ptCount val="4"/>
                  <c:pt idx="0">
                    <c:v>7.4072043988188924E-2</c:v>
                  </c:pt>
                  <c:pt idx="1">
                    <c:v>8.2163114506014989E-2</c:v>
                  </c:pt>
                  <c:pt idx="2">
                    <c:v>1.8550025363635829</c:v>
                  </c:pt>
                  <c:pt idx="3">
                    <c:v>0.42476562949596242</c:v>
                  </c:pt>
                </c:numCache>
              </c:numRef>
            </c:minus>
          </c:errBars>
          <c:cat>
            <c:strRef>
              <c:f>'Antho in Nt'!$D$19:$D$22</c:f>
              <c:strCache>
                <c:ptCount val="4"/>
                <c:pt idx="0">
                  <c:v>AcMYB110 only</c:v>
                </c:pt>
                <c:pt idx="1">
                  <c:v>AcMYB110+F3'5'H</c:v>
                </c:pt>
                <c:pt idx="2">
                  <c:v>AcMYB110+R6:F3'5'H</c:v>
                </c:pt>
                <c:pt idx="3">
                  <c:v>AcMYB110+35S:F3'5'H</c:v>
                </c:pt>
              </c:strCache>
            </c:strRef>
          </c:cat>
          <c:val>
            <c:numRef>
              <c:f>'Antho in Nt'!$K$19:$K$22</c:f>
              <c:numCache>
                <c:formatCode>General</c:formatCode>
                <c:ptCount val="4"/>
                <c:pt idx="0">
                  <c:v>0.83496433326896879</c:v>
                </c:pt>
                <c:pt idx="1">
                  <c:v>0.97775481969817568</c:v>
                </c:pt>
                <c:pt idx="2">
                  <c:v>6.7035782262675845</c:v>
                </c:pt>
                <c:pt idx="3">
                  <c:v>3.033095646018518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24474408"/>
        <c:axId val="424474800"/>
      </c:barChart>
      <c:catAx>
        <c:axId val="4244744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424474800"/>
        <c:crosses val="autoZero"/>
        <c:auto val="1"/>
        <c:lblAlgn val="ctr"/>
        <c:lblOffset val="100"/>
        <c:noMultiLvlLbl val="0"/>
      </c:catAx>
      <c:valAx>
        <c:axId val="424474800"/>
        <c:scaling>
          <c:orientation val="minMax"/>
          <c:max val="9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NZ" sz="800" dirty="0" err="1" smtClean="0"/>
                  <a:t>Dp</a:t>
                </a:r>
                <a:r>
                  <a:rPr lang="en-NZ" sz="800" dirty="0" smtClean="0"/>
                  <a:t>/Cy ratio</a:t>
                </a:r>
                <a:endParaRPr lang="en-NZ" sz="80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424474408"/>
        <c:crosses val="autoZero"/>
        <c:crossBetween val="between"/>
        <c:majorUnit val="2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861625315703467"/>
          <c:y val="6.2394431455183023E-2"/>
          <c:w val="0.73852027930470965"/>
          <c:h val="0.570870325622137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ntho in Nt'!$N$23</c:f>
              <c:strCache>
                <c:ptCount val="1"/>
                <c:pt idx="0">
                  <c:v>Cy-glu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ntho in Nt'!$O$24:$O$27</c:f>
                <c:numCache>
                  <c:formatCode>General</c:formatCode>
                  <c:ptCount val="4"/>
                  <c:pt idx="0">
                    <c:v>0.22184441986161621</c:v>
                  </c:pt>
                  <c:pt idx="1">
                    <c:v>3.6215906587378242E-2</c:v>
                  </c:pt>
                  <c:pt idx="2">
                    <c:v>2.4938535781090308E-2</c:v>
                  </c:pt>
                  <c:pt idx="3">
                    <c:v>3.621247216328654E-2</c:v>
                  </c:pt>
                </c:numCache>
              </c:numRef>
            </c:plus>
            <c:minus>
              <c:numRef>
                <c:f>'Antho in Nt'!$O$24:$O$27</c:f>
                <c:numCache>
                  <c:formatCode>General</c:formatCode>
                  <c:ptCount val="4"/>
                  <c:pt idx="0">
                    <c:v>0.22184441986161621</c:v>
                  </c:pt>
                  <c:pt idx="1">
                    <c:v>3.6215906587378242E-2</c:v>
                  </c:pt>
                  <c:pt idx="2">
                    <c:v>2.4938535781090308E-2</c:v>
                  </c:pt>
                  <c:pt idx="3">
                    <c:v>3.621247216328654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Antho in Nt'!$M$24:$M$27</c:f>
              <c:strCache>
                <c:ptCount val="4"/>
                <c:pt idx="0">
                  <c:v>AcMYB110 only</c:v>
                </c:pt>
                <c:pt idx="1">
                  <c:v>AcMYB110+F3'5'H</c:v>
                </c:pt>
                <c:pt idx="2">
                  <c:v>AcMYB110+R6:F3'5'H</c:v>
                </c:pt>
                <c:pt idx="3">
                  <c:v>AcMYB110+35S:F3'5'H</c:v>
                </c:pt>
              </c:strCache>
            </c:strRef>
          </c:cat>
          <c:val>
            <c:numRef>
              <c:f>'Antho in Nt'!$N$24:$N$27</c:f>
              <c:numCache>
                <c:formatCode>General</c:formatCode>
                <c:ptCount val="4"/>
                <c:pt idx="0">
                  <c:v>0.65839414209589187</c:v>
                </c:pt>
                <c:pt idx="1">
                  <c:v>0.63298133249448829</c:v>
                </c:pt>
                <c:pt idx="2">
                  <c:v>2.4938535781090308E-2</c:v>
                </c:pt>
                <c:pt idx="3">
                  <c:v>0.14707239822974719</c:v>
                </c:pt>
              </c:numCache>
            </c:numRef>
          </c:val>
        </c:ser>
        <c:ser>
          <c:idx val="1"/>
          <c:order val="1"/>
          <c:tx>
            <c:strRef>
              <c:f>'Antho in Nt'!$P$23</c:f>
              <c:strCache>
                <c:ptCount val="1"/>
                <c:pt idx="0">
                  <c:v>Cy-rut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ntho in Nt'!$Q$24:$Q$27</c:f>
                <c:numCache>
                  <c:formatCode>General</c:formatCode>
                  <c:ptCount val="4"/>
                  <c:pt idx="0">
                    <c:v>17.221144695405172</c:v>
                  </c:pt>
                  <c:pt idx="1">
                    <c:v>13.051701742404259</c:v>
                  </c:pt>
                  <c:pt idx="2">
                    <c:v>0.84690100634682453</c:v>
                  </c:pt>
                  <c:pt idx="3">
                    <c:v>16.632826259650766</c:v>
                  </c:pt>
                </c:numCache>
              </c:numRef>
            </c:plus>
            <c:minus>
              <c:numRef>
                <c:f>'Antho in Nt'!$Q$24:$Q$27</c:f>
                <c:numCache>
                  <c:formatCode>General</c:formatCode>
                  <c:ptCount val="4"/>
                  <c:pt idx="0">
                    <c:v>17.221144695405172</c:v>
                  </c:pt>
                  <c:pt idx="1">
                    <c:v>13.051701742404259</c:v>
                  </c:pt>
                  <c:pt idx="2">
                    <c:v>0.84690100634682453</c:v>
                  </c:pt>
                  <c:pt idx="3">
                    <c:v>16.632826259650766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Antho in Nt'!$M$24:$M$27</c:f>
              <c:strCache>
                <c:ptCount val="4"/>
                <c:pt idx="0">
                  <c:v>AcMYB110 only</c:v>
                </c:pt>
                <c:pt idx="1">
                  <c:v>AcMYB110+F3'5'H</c:v>
                </c:pt>
                <c:pt idx="2">
                  <c:v>AcMYB110+R6:F3'5'H</c:v>
                </c:pt>
                <c:pt idx="3">
                  <c:v>AcMYB110+35S:F3'5'H</c:v>
                </c:pt>
              </c:strCache>
            </c:strRef>
          </c:cat>
          <c:val>
            <c:numRef>
              <c:f>'Antho in Nt'!$P$24:$P$27</c:f>
              <c:numCache>
                <c:formatCode>General</c:formatCode>
                <c:ptCount val="4"/>
                <c:pt idx="0">
                  <c:v>91.070950814708397</c:v>
                </c:pt>
                <c:pt idx="1">
                  <c:v>125.07040379286626</c:v>
                </c:pt>
                <c:pt idx="2">
                  <c:v>15.092980027607975</c:v>
                </c:pt>
                <c:pt idx="3">
                  <c:v>41.590992745209597</c:v>
                </c:pt>
              </c:numCache>
            </c:numRef>
          </c:val>
        </c:ser>
        <c:ser>
          <c:idx val="2"/>
          <c:order val="2"/>
          <c:tx>
            <c:strRef>
              <c:f>'Antho in Nt'!$R$23</c:f>
              <c:strCache>
                <c:ptCount val="1"/>
                <c:pt idx="0">
                  <c:v>Dp-rut</c:v>
                </c:pt>
              </c:strCache>
            </c:strRef>
          </c:tx>
          <c:spPr>
            <a:solidFill>
              <a:schemeClr val="dk1">
                <a:tint val="7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ntho in Nt'!$S$24:$S$27</c:f>
                <c:numCache>
                  <c:formatCode>General</c:formatCode>
                  <c:ptCount val="4"/>
                  <c:pt idx="0">
                    <c:v>12.033905716365719</c:v>
                  </c:pt>
                  <c:pt idx="1">
                    <c:v>3.5557706547753587</c:v>
                  </c:pt>
                  <c:pt idx="2">
                    <c:v>24.994952268927129</c:v>
                  </c:pt>
                  <c:pt idx="3">
                    <c:v>29.223519138548642</c:v>
                  </c:pt>
                </c:numCache>
              </c:numRef>
            </c:plus>
            <c:minus>
              <c:numRef>
                <c:f>'Antho in Nt'!$S$24:$S$27</c:f>
                <c:numCache>
                  <c:formatCode>General</c:formatCode>
                  <c:ptCount val="4"/>
                  <c:pt idx="0">
                    <c:v>12.033905716365719</c:v>
                  </c:pt>
                  <c:pt idx="1">
                    <c:v>3.5557706547753587</c:v>
                  </c:pt>
                  <c:pt idx="2">
                    <c:v>24.994952268927129</c:v>
                  </c:pt>
                  <c:pt idx="3">
                    <c:v>29.22351913854864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Antho in Nt'!$M$24:$M$27</c:f>
              <c:strCache>
                <c:ptCount val="4"/>
                <c:pt idx="0">
                  <c:v>AcMYB110 only</c:v>
                </c:pt>
                <c:pt idx="1">
                  <c:v>AcMYB110+F3'5'H</c:v>
                </c:pt>
                <c:pt idx="2">
                  <c:v>AcMYB110+R6:F3'5'H</c:v>
                </c:pt>
                <c:pt idx="3">
                  <c:v>AcMYB110+35S:F3'5'H</c:v>
                </c:pt>
              </c:strCache>
            </c:strRef>
          </c:cat>
          <c:val>
            <c:numRef>
              <c:f>'Antho in Nt'!$R$24:$R$27</c:f>
              <c:numCache>
                <c:formatCode>General</c:formatCode>
                <c:ptCount val="4"/>
                <c:pt idx="0">
                  <c:v>75.41356857127937</c:v>
                </c:pt>
                <c:pt idx="1">
                  <c:v>120.75951097989022</c:v>
                </c:pt>
                <c:pt idx="2">
                  <c:v>100.19926159544518</c:v>
                </c:pt>
                <c:pt idx="3">
                  <c:v>114.333795621934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4475584"/>
        <c:axId val="424338200"/>
      </c:barChart>
      <c:catAx>
        <c:axId val="4244755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338200"/>
        <c:crosses val="autoZero"/>
        <c:auto val="1"/>
        <c:lblAlgn val="ctr"/>
        <c:lblOffset val="100"/>
        <c:noMultiLvlLbl val="0"/>
      </c:catAx>
      <c:valAx>
        <c:axId val="424338200"/>
        <c:scaling>
          <c:orientation val="minMax"/>
          <c:max val="16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NZ" sz="800"/>
                  <a:t>Concentration</a:t>
                </a:r>
                <a:r>
                  <a:rPr lang="en-NZ" sz="800" baseline="0"/>
                  <a:t> Cy-eq (ug/g FW)</a:t>
                </a:r>
                <a:endParaRPr lang="en-NZ" sz="800"/>
              </a:p>
            </c:rich>
          </c:tx>
          <c:layout>
            <c:manualLayout>
              <c:xMode val="edge"/>
              <c:yMode val="edge"/>
              <c:x val="3.6462842604092563E-2"/>
              <c:y val="8.685892407540822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475584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r"/>
      <c:layout>
        <c:manualLayout>
          <c:xMode val="edge"/>
          <c:yMode val="edge"/>
          <c:x val="0.1661284682446853"/>
          <c:y val="1.5696469179767056E-2"/>
          <c:w val="0.16415807458030013"/>
          <c:h val="0.2310914673537882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effectLst/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ncreasing number of repeats'!$L$34</c:f>
              <c:strCache>
                <c:ptCount val="1"/>
                <c:pt idx="0">
                  <c:v>R0</c:v>
                </c:pt>
              </c:strCache>
            </c:strRef>
          </c:tx>
          <c:spPr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dLbls>
            <c:dLbl>
              <c:idx val="1"/>
              <c:layout>
                <c:manualLayout>
                  <c:x val="-4.3497023707590413E-2"/>
                  <c:y val="9.2592592592592397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layout>
                <c:manualLayout>
                  <c:x val="-6.9611912627203829E-2"/>
                  <c:y val="1.388888888888888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increasing number of repeats'!$P$34:$P$37</c:f>
                <c:numCache>
                  <c:formatCode>General</c:formatCode>
                  <c:ptCount val="4"/>
                  <c:pt idx="0">
                    <c:v>9.8662203304187054E-2</c:v>
                  </c:pt>
                  <c:pt idx="1">
                    <c:v>2.2007212010171813</c:v>
                  </c:pt>
                  <c:pt idx="2">
                    <c:v>1.2689425119478501</c:v>
                  </c:pt>
                  <c:pt idx="3">
                    <c:v>0.35486265727977395</c:v>
                  </c:pt>
                </c:numCache>
              </c:numRef>
            </c:plus>
            <c:minus>
              <c:numRef>
                <c:f>'increasing number of repeats'!$P$34:$P$37</c:f>
                <c:numCache>
                  <c:formatCode>General</c:formatCode>
                  <c:ptCount val="4"/>
                  <c:pt idx="0">
                    <c:v>9.8662203304187054E-2</c:v>
                  </c:pt>
                  <c:pt idx="1">
                    <c:v>2.2007212010171813</c:v>
                  </c:pt>
                  <c:pt idx="2">
                    <c:v>1.2689425119478501</c:v>
                  </c:pt>
                  <c:pt idx="3">
                    <c:v>0.35486265727977395</c:v>
                  </c:pt>
                </c:numCache>
              </c:numRef>
            </c:minus>
          </c:errBars>
          <c:cat>
            <c:strRef>
              <c:f>'increasing number of repeats'!$O$33</c:f>
              <c:strCache>
                <c:ptCount val="1"/>
                <c:pt idx="0">
                  <c:v>AcMYB110 / F3'5'H</c:v>
                </c:pt>
              </c:strCache>
            </c:strRef>
          </c:cat>
          <c:val>
            <c:numRef>
              <c:f>'increasing number of repeats'!$O$34</c:f>
              <c:numCache>
                <c:formatCode>0.0</c:formatCode>
                <c:ptCount val="1"/>
                <c:pt idx="0">
                  <c:v>1.1691315195255121</c:v>
                </c:pt>
              </c:numCache>
            </c:numRef>
          </c:val>
        </c:ser>
        <c:ser>
          <c:idx val="1"/>
          <c:order val="1"/>
          <c:tx>
            <c:strRef>
              <c:f>'increasing number of repeats'!$L$35</c:f>
              <c:strCache>
                <c:ptCount val="1"/>
                <c:pt idx="0">
                  <c:v>R6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dLbls>
            <c:dLbl>
              <c:idx val="0"/>
              <c:layout>
                <c:manualLayout>
                  <c:x val="-5.9550603946282608E-2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increasing number of repeats'!$P$35</c:f>
                <c:numCache>
                  <c:formatCode>General</c:formatCode>
                  <c:ptCount val="1"/>
                  <c:pt idx="0">
                    <c:v>2.2007212010171813</c:v>
                  </c:pt>
                </c:numCache>
              </c:numRef>
            </c:plus>
            <c:minus>
              <c:numRef>
                <c:f>'increasing number of repeats'!$P$35</c:f>
                <c:numCache>
                  <c:formatCode>General</c:formatCode>
                  <c:ptCount val="1"/>
                  <c:pt idx="0">
                    <c:v>2.2007212010171813</c:v>
                  </c:pt>
                </c:numCache>
              </c:numRef>
            </c:minus>
          </c:errBars>
          <c:cat>
            <c:strRef>
              <c:f>'increasing number of repeats'!$O$33</c:f>
              <c:strCache>
                <c:ptCount val="1"/>
                <c:pt idx="0">
                  <c:v>AcMYB110 / F3'5'H</c:v>
                </c:pt>
              </c:strCache>
            </c:strRef>
          </c:cat>
          <c:val>
            <c:numRef>
              <c:f>'increasing number of repeats'!$O$35</c:f>
              <c:numCache>
                <c:formatCode>0.0</c:formatCode>
                <c:ptCount val="1"/>
                <c:pt idx="0">
                  <c:v>7.9828371633857609</c:v>
                </c:pt>
              </c:numCache>
            </c:numRef>
          </c:val>
        </c:ser>
        <c:ser>
          <c:idx val="2"/>
          <c:order val="2"/>
          <c:tx>
            <c:strRef>
              <c:f>'increasing number of repeats'!$L$36</c:f>
              <c:strCache>
                <c:ptCount val="1"/>
                <c:pt idx="0">
                  <c:v>R12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dLbls>
            <c:dLbl>
              <c:idx val="0"/>
              <c:layout>
                <c:manualLayout>
                  <c:x val="-7.656506221664898E-2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increasing number of repeats'!$P$36</c:f>
                <c:numCache>
                  <c:formatCode>General</c:formatCode>
                  <c:ptCount val="1"/>
                  <c:pt idx="0">
                    <c:v>1.2689425119478501</c:v>
                  </c:pt>
                </c:numCache>
              </c:numRef>
            </c:plus>
            <c:minus>
              <c:numRef>
                <c:f>'increasing number of repeats'!$P$36</c:f>
                <c:numCache>
                  <c:formatCode>General</c:formatCode>
                  <c:ptCount val="1"/>
                  <c:pt idx="0">
                    <c:v>1.2689425119478501</c:v>
                  </c:pt>
                </c:numCache>
              </c:numRef>
            </c:minus>
          </c:errBars>
          <c:cat>
            <c:strRef>
              <c:f>'increasing number of repeats'!$O$33</c:f>
              <c:strCache>
                <c:ptCount val="1"/>
                <c:pt idx="0">
                  <c:v>AcMYB110 / F3'5'H</c:v>
                </c:pt>
              </c:strCache>
            </c:strRef>
          </c:cat>
          <c:val>
            <c:numRef>
              <c:f>'increasing number of repeats'!$O$36</c:f>
              <c:numCache>
                <c:formatCode>0.0</c:formatCode>
                <c:ptCount val="1"/>
                <c:pt idx="0">
                  <c:v>11.262973305928888</c:v>
                </c:pt>
              </c:numCache>
            </c:numRef>
          </c:val>
        </c:ser>
        <c:ser>
          <c:idx val="3"/>
          <c:order val="3"/>
          <c:tx>
            <c:strRef>
              <c:f>'increasing number of repeats'!$L$37</c:f>
              <c:strCache>
                <c:ptCount val="1"/>
                <c:pt idx="0">
                  <c:v>R30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increasing number of repeats'!$P$37</c:f>
                <c:numCache>
                  <c:formatCode>General</c:formatCode>
                  <c:ptCount val="1"/>
                  <c:pt idx="0">
                    <c:v>0.35486265727977395</c:v>
                  </c:pt>
                </c:numCache>
              </c:numRef>
            </c:plus>
            <c:minus>
              <c:numRef>
                <c:f>'increasing number of repeats'!$P$37</c:f>
                <c:numCache>
                  <c:formatCode>General</c:formatCode>
                  <c:ptCount val="1"/>
                  <c:pt idx="0">
                    <c:v>0.35486265727977395</c:v>
                  </c:pt>
                </c:numCache>
              </c:numRef>
            </c:minus>
          </c:errBars>
          <c:cat>
            <c:strRef>
              <c:f>'increasing number of repeats'!$O$33</c:f>
              <c:strCache>
                <c:ptCount val="1"/>
                <c:pt idx="0">
                  <c:v>AcMYB110 / F3'5'H</c:v>
                </c:pt>
              </c:strCache>
            </c:strRef>
          </c:cat>
          <c:val>
            <c:numRef>
              <c:f>'increasing number of repeats'!$O$37</c:f>
              <c:numCache>
                <c:formatCode>0.0</c:formatCode>
                <c:ptCount val="1"/>
                <c:pt idx="0">
                  <c:v>7.75548077718976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424339376"/>
        <c:axId val="424339768"/>
      </c:barChart>
      <c:catAx>
        <c:axId val="4243393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24339768"/>
        <c:crosses val="autoZero"/>
        <c:auto val="1"/>
        <c:lblAlgn val="ctr"/>
        <c:lblOffset val="100"/>
        <c:noMultiLvlLbl val="0"/>
      </c:catAx>
      <c:valAx>
        <c:axId val="4243397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NZ"/>
                  <a:t>Dp/Cy ratio (fold increase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42433937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ncreasing number of repeats'!$B$5</c:f>
              <c:strCache>
                <c:ptCount val="1"/>
                <c:pt idx="0">
                  <c:v>R0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increasing number of repeats'!$D$5,'increasing number of repeats'!$F$5)</c:f>
                <c:numCache>
                  <c:formatCode>General</c:formatCode>
                  <c:ptCount val="2"/>
                  <c:pt idx="0">
                    <c:v>6.0669414356585502E-2</c:v>
                  </c:pt>
                  <c:pt idx="1">
                    <c:v>0.31827171610071464</c:v>
                  </c:pt>
                </c:numCache>
              </c:numRef>
            </c:plus>
            <c:minus>
              <c:numRef>
                <c:f>('increasing number of repeats'!$D$8,'increasing number of repeats'!$D$8,'increasing number of repeats'!$D$5,'increasing number of repeats'!$F$5)</c:f>
                <c:numCache>
                  <c:formatCode>General</c:formatCode>
                  <c:ptCount val="4"/>
                  <c:pt idx="0">
                    <c:v>0.2474712203797243</c:v>
                  </c:pt>
                  <c:pt idx="1">
                    <c:v>0.2474712203797243</c:v>
                  </c:pt>
                  <c:pt idx="2">
                    <c:v>6.0669414356585502E-2</c:v>
                  </c:pt>
                  <c:pt idx="3">
                    <c:v>0.31827171610071464</c:v>
                  </c:pt>
                </c:numCache>
              </c:numRef>
            </c:minus>
          </c:errBars>
          <c:cat>
            <c:strRef>
              <c:f>('increasing number of repeats'!$C$4,'increasing number of repeats'!$E$4)</c:f>
              <c:strCache>
                <c:ptCount val="2"/>
                <c:pt idx="0">
                  <c:v>no TF /      F3'5'H:LUC</c:v>
                </c:pt>
                <c:pt idx="1">
                  <c:v>AcMYB110 / F3'5'H:LUC</c:v>
                </c:pt>
              </c:strCache>
            </c:strRef>
          </c:cat>
          <c:val>
            <c:numRef>
              <c:f>('increasing number of repeats'!$C$5,'increasing number of repeats'!$E$5)</c:f>
              <c:numCache>
                <c:formatCode>0.00</c:formatCode>
                <c:ptCount val="2"/>
                <c:pt idx="0">
                  <c:v>0.73685579021746261</c:v>
                </c:pt>
                <c:pt idx="1">
                  <c:v>2.5344673678111289</c:v>
                </c:pt>
              </c:numCache>
            </c:numRef>
          </c:val>
        </c:ser>
        <c:ser>
          <c:idx val="1"/>
          <c:order val="1"/>
          <c:tx>
            <c:strRef>
              <c:f>'increasing number of repeats'!$B$6</c:f>
              <c:strCache>
                <c:ptCount val="1"/>
                <c:pt idx="0">
                  <c:v>R6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increasing number of repeats'!$D$6,'increasing number of repeats'!$F$6)</c:f>
                <c:numCache>
                  <c:formatCode>General</c:formatCode>
                  <c:ptCount val="2"/>
                  <c:pt idx="0">
                    <c:v>3.7536935813524221E-2</c:v>
                  </c:pt>
                  <c:pt idx="1">
                    <c:v>0.49405837354167725</c:v>
                  </c:pt>
                </c:numCache>
              </c:numRef>
            </c:plus>
            <c:minus>
              <c:numRef>
                <c:f>('increasing number of repeats'!$D$6,'increasing number of repeats'!$F$6)</c:f>
                <c:numCache>
                  <c:formatCode>General</c:formatCode>
                  <c:ptCount val="2"/>
                  <c:pt idx="0">
                    <c:v>3.7536935813524221E-2</c:v>
                  </c:pt>
                  <c:pt idx="1">
                    <c:v>0.49405837354167725</c:v>
                  </c:pt>
                </c:numCache>
              </c:numRef>
            </c:minus>
          </c:errBars>
          <c:cat>
            <c:strRef>
              <c:f>('increasing number of repeats'!$C$4,'increasing number of repeats'!$E$4)</c:f>
              <c:strCache>
                <c:ptCount val="2"/>
                <c:pt idx="0">
                  <c:v>no TF /      F3'5'H:LUC</c:v>
                </c:pt>
                <c:pt idx="1">
                  <c:v>AcMYB110 / F3'5'H:LUC</c:v>
                </c:pt>
              </c:strCache>
            </c:strRef>
          </c:cat>
          <c:val>
            <c:numRef>
              <c:f>('increasing number of repeats'!$C$6,'increasing number of repeats'!$E$6)</c:f>
              <c:numCache>
                <c:formatCode>0.00</c:formatCode>
                <c:ptCount val="2"/>
                <c:pt idx="0">
                  <c:v>0.73657537281294583</c:v>
                </c:pt>
                <c:pt idx="1">
                  <c:v>9.0600492414434406</c:v>
                </c:pt>
              </c:numCache>
            </c:numRef>
          </c:val>
        </c:ser>
        <c:ser>
          <c:idx val="2"/>
          <c:order val="2"/>
          <c:tx>
            <c:strRef>
              <c:f>'increasing number of repeats'!$B$7</c:f>
              <c:strCache>
                <c:ptCount val="1"/>
                <c:pt idx="0">
                  <c:v>R12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increasing number of repeats'!$D$7,'increasing number of repeats'!$F$7)</c:f>
                <c:numCache>
                  <c:formatCode>General</c:formatCode>
                  <c:ptCount val="2"/>
                  <c:pt idx="0">
                    <c:v>7.2245753943072546E-2</c:v>
                  </c:pt>
                  <c:pt idx="1">
                    <c:v>1.5943218107602657</c:v>
                  </c:pt>
                </c:numCache>
              </c:numRef>
            </c:plus>
            <c:minus>
              <c:numRef>
                <c:f>('increasing number of repeats'!$D$7,'increasing number of repeats'!$F$7)</c:f>
                <c:numCache>
                  <c:formatCode>General</c:formatCode>
                  <c:ptCount val="2"/>
                  <c:pt idx="0">
                    <c:v>7.2245753943072546E-2</c:v>
                  </c:pt>
                  <c:pt idx="1">
                    <c:v>1.5943218107602657</c:v>
                  </c:pt>
                </c:numCache>
              </c:numRef>
            </c:minus>
          </c:errBars>
          <c:cat>
            <c:strRef>
              <c:f>('increasing number of repeats'!$C$4,'increasing number of repeats'!$E$4)</c:f>
              <c:strCache>
                <c:ptCount val="2"/>
                <c:pt idx="0">
                  <c:v>no TF /      F3'5'H:LUC</c:v>
                </c:pt>
                <c:pt idx="1">
                  <c:v>AcMYB110 / F3'5'H:LUC</c:v>
                </c:pt>
              </c:strCache>
            </c:strRef>
          </c:cat>
          <c:val>
            <c:numRef>
              <c:f>('increasing number of repeats'!$C$7,'increasing number of repeats'!$E$7)</c:f>
              <c:numCache>
                <c:formatCode>0.00</c:formatCode>
                <c:ptCount val="2"/>
                <c:pt idx="0">
                  <c:v>0.7946345051444742</c:v>
                </c:pt>
                <c:pt idx="1">
                  <c:v>17.956501879261506</c:v>
                </c:pt>
              </c:numCache>
            </c:numRef>
          </c:val>
        </c:ser>
        <c:ser>
          <c:idx val="3"/>
          <c:order val="3"/>
          <c:tx>
            <c:strRef>
              <c:f>'increasing number of repeats'!$B$8</c:f>
              <c:strCache>
                <c:ptCount val="1"/>
                <c:pt idx="0">
                  <c:v>R30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increasing number of repeats'!$D$8,'increasing number of repeats'!$F$8)</c:f>
                <c:numCache>
                  <c:formatCode>General</c:formatCode>
                  <c:ptCount val="2"/>
                  <c:pt idx="0">
                    <c:v>0.2474712203797243</c:v>
                  </c:pt>
                  <c:pt idx="1">
                    <c:v>0.88695896074576897</c:v>
                  </c:pt>
                </c:numCache>
              </c:numRef>
            </c:plus>
            <c:minus>
              <c:numRef>
                <c:f>('increasing number of repeats'!$D$8,'increasing number of repeats'!$F$8)</c:f>
                <c:numCache>
                  <c:formatCode>General</c:formatCode>
                  <c:ptCount val="2"/>
                  <c:pt idx="0">
                    <c:v>0.2474712203797243</c:v>
                  </c:pt>
                  <c:pt idx="1">
                    <c:v>0.88695896074576897</c:v>
                  </c:pt>
                </c:numCache>
              </c:numRef>
            </c:minus>
          </c:errBars>
          <c:cat>
            <c:strRef>
              <c:f>('increasing number of repeats'!$C$4,'increasing number of repeats'!$E$4)</c:f>
              <c:strCache>
                <c:ptCount val="2"/>
                <c:pt idx="0">
                  <c:v>no TF /      F3'5'H:LUC</c:v>
                </c:pt>
                <c:pt idx="1">
                  <c:v>AcMYB110 / F3'5'H:LUC</c:v>
                </c:pt>
              </c:strCache>
            </c:strRef>
          </c:cat>
          <c:val>
            <c:numRef>
              <c:f>('increasing number of repeats'!$C$8,'increasing number of repeats'!$E$8)</c:f>
              <c:numCache>
                <c:formatCode>0.00</c:formatCode>
                <c:ptCount val="2"/>
                <c:pt idx="0">
                  <c:v>0.92036449917959717</c:v>
                </c:pt>
                <c:pt idx="1">
                  <c:v>19.5803461183281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424340552"/>
        <c:axId val="424340944"/>
      </c:barChart>
      <c:catAx>
        <c:axId val="424340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424340944"/>
        <c:crosses val="autoZero"/>
        <c:auto val="1"/>
        <c:lblAlgn val="ctr"/>
        <c:lblOffset val="100"/>
        <c:noMultiLvlLbl val="0"/>
      </c:catAx>
      <c:valAx>
        <c:axId val="424340944"/>
        <c:scaling>
          <c:orientation val="minMax"/>
          <c:max val="22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NZ" sz="1000" b="1" i="0" baseline="0" dirty="0"/>
                  <a:t>LUC/REN ratio</a:t>
                </a:r>
                <a:endParaRPr lang="en-NZ" sz="1000" dirty="0"/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424340552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24808340847992824"/>
          <c:y val="0.12886191309419656"/>
          <c:w val="0.14609134056813669"/>
          <c:h val="0.33486876640419982"/>
        </c:manualLayout>
      </c:layout>
      <c:overlay val="0"/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6C1B4B-BDEC-4EE2-903F-61A0CB0EDA03}" type="datetimeFigureOut">
              <a:rPr lang="en-NZ" smtClean="0"/>
              <a:pPr/>
              <a:t>8/09/2017</a:t>
            </a:fld>
            <a:endParaRPr lang="en-N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81200" y="739775"/>
            <a:ext cx="2773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951880-DC5F-488B-84A8-53AD512F8292}" type="slidenum">
              <a:rPr lang="en-NZ" smtClean="0"/>
              <a:pPr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752617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FEE86-CF86-42EB-9527-509996B3F0A3}" type="datetimeFigureOut">
              <a:rPr lang="en-NZ" smtClean="0"/>
              <a:pPr/>
              <a:t>8/09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5E74B-810A-4094-9A7B-3D3742BD7EE4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FEE86-CF86-42EB-9527-509996B3F0A3}" type="datetimeFigureOut">
              <a:rPr lang="en-NZ" smtClean="0"/>
              <a:pPr/>
              <a:t>8/09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5E74B-810A-4094-9A7B-3D3742BD7EE4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FEE86-CF86-42EB-9527-509996B3F0A3}" type="datetimeFigureOut">
              <a:rPr lang="en-NZ" smtClean="0"/>
              <a:pPr/>
              <a:t>8/09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5E74B-810A-4094-9A7B-3D3742BD7EE4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FEE86-CF86-42EB-9527-509996B3F0A3}" type="datetimeFigureOut">
              <a:rPr lang="en-NZ" smtClean="0"/>
              <a:pPr/>
              <a:t>8/09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5E74B-810A-4094-9A7B-3D3742BD7EE4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FEE86-CF86-42EB-9527-509996B3F0A3}" type="datetimeFigureOut">
              <a:rPr lang="en-NZ" smtClean="0"/>
              <a:pPr/>
              <a:t>8/09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5E74B-810A-4094-9A7B-3D3742BD7EE4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FEE86-CF86-42EB-9527-509996B3F0A3}" type="datetimeFigureOut">
              <a:rPr lang="en-NZ" smtClean="0"/>
              <a:pPr/>
              <a:t>8/09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5E74B-810A-4094-9A7B-3D3742BD7EE4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FEE86-CF86-42EB-9527-509996B3F0A3}" type="datetimeFigureOut">
              <a:rPr lang="en-NZ" smtClean="0"/>
              <a:pPr/>
              <a:t>8/09/2017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5E74B-810A-4094-9A7B-3D3742BD7EE4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FEE86-CF86-42EB-9527-509996B3F0A3}" type="datetimeFigureOut">
              <a:rPr lang="en-NZ" smtClean="0"/>
              <a:pPr/>
              <a:t>8/09/2017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5E74B-810A-4094-9A7B-3D3742BD7EE4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FEE86-CF86-42EB-9527-509996B3F0A3}" type="datetimeFigureOut">
              <a:rPr lang="en-NZ" smtClean="0"/>
              <a:pPr/>
              <a:t>8/09/2017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5E74B-810A-4094-9A7B-3D3742BD7EE4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FEE86-CF86-42EB-9527-509996B3F0A3}" type="datetimeFigureOut">
              <a:rPr lang="en-NZ" smtClean="0"/>
              <a:pPr/>
              <a:t>8/09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5E74B-810A-4094-9A7B-3D3742BD7EE4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FEE86-CF86-42EB-9527-509996B3F0A3}" type="datetimeFigureOut">
              <a:rPr lang="en-NZ" smtClean="0"/>
              <a:pPr/>
              <a:t>8/09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A5E74B-810A-4094-9A7B-3D3742BD7EE4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FFEE86-CF86-42EB-9527-509996B3F0A3}" type="datetimeFigureOut">
              <a:rPr lang="en-NZ" smtClean="0"/>
              <a:pPr/>
              <a:t>8/09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A5E74B-810A-4094-9A7B-3D3742BD7EE4}" type="slidenum">
              <a:rPr lang="en-NZ" smtClean="0"/>
              <a:pPr/>
              <a:t>‹#›</a:t>
            </a:fld>
            <a:endParaRPr lang="en-N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5" name="Rectangle 1"/>
          <p:cNvSpPr>
            <a:spLocks noChangeArrowheads="1"/>
          </p:cNvSpPr>
          <p:nvPr/>
        </p:nvSpPr>
        <p:spPr bwMode="auto">
          <a:xfrm>
            <a:off x="952500" y="7764602"/>
            <a:ext cx="52451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NZ" sz="1000" dirty="0"/>
              <a:t>Supplementary Figure </a:t>
            </a:r>
            <a:r>
              <a:rPr lang="en-NZ" sz="1000" dirty="0" smtClean="0"/>
              <a:t>1</a:t>
            </a:r>
          </a:p>
        </p:txBody>
      </p:sp>
      <p:sp>
        <p:nvSpPr>
          <p:cNvPr id="17" name="Text Box 11"/>
          <p:cNvSpPr txBox="1">
            <a:spLocks noChangeArrowheads="1"/>
          </p:cNvSpPr>
          <p:nvPr/>
        </p:nvSpPr>
        <p:spPr bwMode="auto">
          <a:xfrm>
            <a:off x="760391" y="537390"/>
            <a:ext cx="3097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l"/>
            <a:r>
              <a:rPr lang="en-NZ" sz="1600" b="1" dirty="0" smtClean="0"/>
              <a:t>A</a:t>
            </a:r>
            <a:endParaRPr lang="en-GB" sz="1600" b="1" dirty="0"/>
          </a:p>
        </p:txBody>
      </p:sp>
      <p:sp>
        <p:nvSpPr>
          <p:cNvPr id="18" name="Text Box 11"/>
          <p:cNvSpPr txBox="1">
            <a:spLocks noChangeArrowheads="1"/>
          </p:cNvSpPr>
          <p:nvPr/>
        </p:nvSpPr>
        <p:spPr bwMode="auto">
          <a:xfrm>
            <a:off x="760391" y="1932891"/>
            <a:ext cx="30008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l"/>
            <a:r>
              <a:rPr lang="en-NZ" sz="1600" b="1" dirty="0" smtClean="0"/>
              <a:t>B</a:t>
            </a:r>
            <a:endParaRPr lang="en-GB" sz="1600" b="1" dirty="0"/>
          </a:p>
        </p:txBody>
      </p:sp>
      <p:sp>
        <p:nvSpPr>
          <p:cNvPr id="40" name="Text Box 11"/>
          <p:cNvSpPr txBox="1">
            <a:spLocks noChangeArrowheads="1"/>
          </p:cNvSpPr>
          <p:nvPr/>
        </p:nvSpPr>
        <p:spPr bwMode="auto">
          <a:xfrm>
            <a:off x="760391" y="4287834"/>
            <a:ext cx="30008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l"/>
            <a:r>
              <a:rPr lang="en-NZ" sz="1600" b="1" dirty="0" smtClean="0"/>
              <a:t>C</a:t>
            </a:r>
            <a:endParaRPr lang="en-GB" sz="1600" b="1" dirty="0"/>
          </a:p>
        </p:txBody>
      </p:sp>
      <p:sp>
        <p:nvSpPr>
          <p:cNvPr id="41" name="Text Box 11"/>
          <p:cNvSpPr txBox="1">
            <a:spLocks noChangeArrowheads="1"/>
          </p:cNvSpPr>
          <p:nvPr/>
        </p:nvSpPr>
        <p:spPr bwMode="auto">
          <a:xfrm>
            <a:off x="3979841" y="4335334"/>
            <a:ext cx="31451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l"/>
            <a:r>
              <a:rPr lang="en-NZ" sz="1600" b="1" dirty="0" smtClean="0"/>
              <a:t>D</a:t>
            </a:r>
            <a:endParaRPr lang="en-GB" sz="16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14497" y="475704"/>
            <a:ext cx="4114408" cy="10529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25" name="Group 24"/>
          <p:cNvGrpSpPr/>
          <p:nvPr/>
        </p:nvGrpSpPr>
        <p:grpSpPr>
          <a:xfrm>
            <a:off x="1634489" y="1989929"/>
            <a:ext cx="3863341" cy="2164630"/>
            <a:chOff x="1962149" y="1922144"/>
            <a:chExt cx="3656661" cy="2048827"/>
          </a:xfrm>
        </p:grpSpPr>
        <p:graphicFrame>
          <p:nvGraphicFramePr>
            <p:cNvPr id="23" name="Chart 22"/>
            <p:cNvGraphicFramePr/>
            <p:nvPr>
              <p:extLst>
                <p:ext uri="{D42A27DB-BD31-4B8C-83A1-F6EECF244321}">
                  <p14:modId xmlns:p14="http://schemas.microsoft.com/office/powerpoint/2010/main" val="1797828003"/>
                </p:ext>
              </p:extLst>
            </p:nvPr>
          </p:nvGraphicFramePr>
          <p:xfrm>
            <a:off x="3682366" y="1922144"/>
            <a:ext cx="1936444" cy="20488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24" name="Chart 23"/>
            <p:cNvGraphicFramePr/>
            <p:nvPr>
              <p:extLst>
                <p:ext uri="{D42A27DB-BD31-4B8C-83A1-F6EECF244321}">
                  <p14:modId xmlns:p14="http://schemas.microsoft.com/office/powerpoint/2010/main" val="356520151"/>
                </p:ext>
              </p:extLst>
            </p:nvPr>
          </p:nvGraphicFramePr>
          <p:xfrm>
            <a:off x="1962149" y="1922144"/>
            <a:ext cx="1893571" cy="20488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graphicFrame>
        <p:nvGraphicFramePr>
          <p:cNvPr id="16" name="Chart 15"/>
          <p:cNvGraphicFramePr/>
          <p:nvPr/>
        </p:nvGraphicFramePr>
        <p:xfrm>
          <a:off x="4352653" y="4421311"/>
          <a:ext cx="1699260" cy="25527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5" name="Text Box 267"/>
          <p:cNvSpPr txBox="1">
            <a:spLocks noChangeArrowheads="1"/>
          </p:cNvSpPr>
          <p:nvPr/>
        </p:nvSpPr>
        <p:spPr bwMode="auto">
          <a:xfrm>
            <a:off x="1514497" y="757874"/>
            <a:ext cx="1836081" cy="26161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NZ" sz="1100" b="1" dirty="0" smtClean="0"/>
              <a:t>AcF3’5’H promoter</a:t>
            </a:r>
          </a:p>
        </p:txBody>
      </p:sp>
      <p:graphicFrame>
        <p:nvGraphicFramePr>
          <p:cNvPr id="34" name="Chart 33"/>
          <p:cNvGraphicFramePr/>
          <p:nvPr>
            <p:extLst>
              <p:ext uri="{D42A27DB-BD31-4B8C-83A1-F6EECF244321}">
                <p14:modId xmlns:p14="http://schemas.microsoft.com/office/powerpoint/2010/main" val="2836825433"/>
              </p:ext>
            </p:extLst>
          </p:nvPr>
        </p:nvGraphicFramePr>
        <p:xfrm>
          <a:off x="977111" y="4457111"/>
          <a:ext cx="3317240" cy="26261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1066800" y="5084600"/>
            <a:ext cx="502157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NZ" sz="1000" dirty="0"/>
              <a:t>Supplementary Figure </a:t>
            </a:r>
            <a:r>
              <a:rPr lang="en-NZ" sz="1000" dirty="0" smtClean="0"/>
              <a:t>2</a:t>
            </a:r>
          </a:p>
        </p:txBody>
      </p:sp>
      <p:sp>
        <p:nvSpPr>
          <p:cNvPr id="8" name="Text Box 11"/>
          <p:cNvSpPr txBox="1">
            <a:spLocks noChangeArrowheads="1"/>
          </p:cNvSpPr>
          <p:nvPr/>
        </p:nvSpPr>
        <p:spPr bwMode="auto">
          <a:xfrm>
            <a:off x="1128691" y="1518997"/>
            <a:ext cx="3097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l"/>
            <a:r>
              <a:rPr lang="en-NZ" sz="1600" b="1" dirty="0" smtClean="0"/>
              <a:t>A</a:t>
            </a:r>
            <a:endParaRPr lang="en-GB" sz="1600" b="1" dirty="0"/>
          </a:p>
        </p:txBody>
      </p:sp>
      <p:sp>
        <p:nvSpPr>
          <p:cNvPr id="9" name="Text Box 11"/>
          <p:cNvSpPr txBox="1">
            <a:spLocks noChangeArrowheads="1"/>
          </p:cNvSpPr>
          <p:nvPr/>
        </p:nvSpPr>
        <p:spPr bwMode="auto">
          <a:xfrm>
            <a:off x="3610906" y="1518997"/>
            <a:ext cx="30008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l"/>
            <a:r>
              <a:rPr lang="en-NZ" sz="1600" b="1" dirty="0" smtClean="0"/>
              <a:t>B</a:t>
            </a:r>
            <a:endParaRPr lang="en-GB" sz="1600" b="1" dirty="0"/>
          </a:p>
        </p:txBody>
      </p:sp>
      <p:graphicFrame>
        <p:nvGraphicFramePr>
          <p:cNvPr id="10" name="Chart 9"/>
          <p:cNvGraphicFramePr/>
          <p:nvPr/>
        </p:nvGraphicFramePr>
        <p:xfrm>
          <a:off x="3730326" y="1628774"/>
          <a:ext cx="1413174" cy="2714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0"/>
          <p:cNvGraphicFramePr/>
          <p:nvPr>
            <p:extLst>
              <p:ext uri="{D42A27DB-BD31-4B8C-83A1-F6EECF244321}">
                <p14:modId xmlns:p14="http://schemas.microsoft.com/office/powerpoint/2010/main" val="2181290000"/>
              </p:ext>
            </p:extLst>
          </p:nvPr>
        </p:nvGraphicFramePr>
        <p:xfrm>
          <a:off x="1170476" y="1600200"/>
          <a:ext cx="26490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437482" y="4046220"/>
            <a:ext cx="6001417" cy="1486097"/>
            <a:chOff x="66578" y="4341709"/>
            <a:chExt cx="7390927" cy="2043374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578" y="4341709"/>
              <a:ext cx="7390927" cy="2043374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2048138" y="4444451"/>
              <a:ext cx="3791164" cy="1940632"/>
            </a:xfrm>
            <a:prstGeom prst="rect">
              <a:avLst/>
            </a:prstGeom>
            <a:noFill/>
            <a:ln w="28575"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167640" y="142001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b="1" dirty="0" smtClean="0"/>
              <a:t>A</a:t>
            </a:r>
            <a:endParaRPr lang="en-NZ" b="1" dirty="0"/>
          </a:p>
        </p:txBody>
      </p:sp>
      <p:grpSp>
        <p:nvGrpSpPr>
          <p:cNvPr id="7" name="Group 6"/>
          <p:cNvGrpSpPr/>
          <p:nvPr/>
        </p:nvGrpSpPr>
        <p:grpSpPr>
          <a:xfrm>
            <a:off x="618619" y="1488595"/>
            <a:ext cx="5820281" cy="2207105"/>
            <a:chOff x="0" y="0"/>
            <a:chExt cx="7115175" cy="2733675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0"/>
              <a:ext cx="7115175" cy="2733675"/>
            </a:xfrm>
            <a:prstGeom prst="rect">
              <a:avLst/>
            </a:prstGeom>
          </p:spPr>
        </p:pic>
        <p:sp>
          <p:nvSpPr>
            <p:cNvPr id="9" name="Rectangle 8"/>
            <p:cNvSpPr/>
            <p:nvPr/>
          </p:nvSpPr>
          <p:spPr>
            <a:xfrm>
              <a:off x="3749100" y="163148"/>
              <a:ext cx="2419518" cy="2570527"/>
            </a:xfrm>
            <a:prstGeom prst="rect">
              <a:avLst/>
            </a:prstGeom>
            <a:noFill/>
            <a:ln w="285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NZ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167640" y="399109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b="1" dirty="0" smtClean="0"/>
              <a:t>B</a:t>
            </a:r>
            <a:endParaRPr lang="en-NZ" b="1" dirty="0"/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701040" y="6383531"/>
            <a:ext cx="502157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NZ" sz="1000" dirty="0"/>
              <a:t>Supplementary Figure </a:t>
            </a:r>
            <a:r>
              <a:rPr lang="en-NZ" sz="1000" dirty="0" smtClean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25785348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028C09C9D97D24780058C99077D8847" ma:contentTypeVersion="7" ma:contentTypeDescription="Create a new document." ma:contentTypeScope="" ma:versionID="0132886fdf3e2c25019eb3cd8923805d">
  <xsd:schema xmlns:xsd="http://www.w3.org/2001/XMLSchema" xmlns:p="http://schemas.microsoft.com/office/2006/metadata/properties" xmlns:ns2="39616538-2d66-4de6-9e6e-2b8794b75252" targetNamespace="http://schemas.microsoft.com/office/2006/metadata/properties" ma:root="true" ma:fieldsID="afb14a4498c4490eaa362745f3dd1134" ns2:_="">
    <xsd:import namespace="39616538-2d66-4de6-9e6e-2b8794b7525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9616538-2d66-4de6-9e6e-2b8794b7525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39616538-2d66-4de6-9e6e-2b8794b75252">Presentation</DocumentType>
    <TitleName xmlns="39616538-2d66-4de6-9e6e-2b8794b75252">Presentation 1.PPTX</TitleName>
    <Checked_x0020_Out_x0020_To xmlns="39616538-2d66-4de6-9e6e-2b8794b75252">
      <UserInfo>
        <DisplayName/>
        <AccountId xsi:nil="true"/>
        <AccountType/>
      </UserInfo>
    </Checked_x0020_Out_x0020_To>
    <FileFormat xmlns="39616538-2d66-4de6-9e6e-2b8794b75252">PPTX</FileFormat>
    <DocumentId xmlns="39616538-2d66-4de6-9e6e-2b8794b75252">Presentation 1.PPTX</DocumentId>
    <StageName xmlns="39616538-2d66-4de6-9e6e-2b8794b75252" xsi:nil="true"/>
    <IsDeleted xmlns="39616538-2d66-4de6-9e6e-2b8794b75252">false</IsDeleted>
  </documentManagement>
</p:properties>
</file>

<file path=customXml/itemProps1.xml><?xml version="1.0" encoding="utf-8"?>
<ds:datastoreItem xmlns:ds="http://schemas.openxmlformats.org/officeDocument/2006/customXml" ds:itemID="{99EA9A7E-9A3A-42F5-9732-F950C8F78D62}"/>
</file>

<file path=customXml/itemProps2.xml><?xml version="1.0" encoding="utf-8"?>
<ds:datastoreItem xmlns:ds="http://schemas.openxmlformats.org/officeDocument/2006/customXml" ds:itemID="{E024F21E-0522-4CEF-A911-09588369784D}"/>
</file>

<file path=customXml/itemProps3.xml><?xml version="1.0" encoding="utf-8"?>
<ds:datastoreItem xmlns:ds="http://schemas.openxmlformats.org/officeDocument/2006/customXml" ds:itemID="{65F32812-8478-437A-936C-F73708CADEB2}"/>
</file>

<file path=docProps/app.xml><?xml version="1.0" encoding="utf-8"?>
<Properties xmlns="http://schemas.openxmlformats.org/officeDocument/2006/extended-properties" xmlns:vt="http://schemas.openxmlformats.org/officeDocument/2006/docPropsVTypes">
  <TotalTime>42905</TotalTime>
  <Words>39</Words>
  <Application>Microsoft Office PowerPoint</Application>
  <PresentationFormat>On-screen Show (4:3)</PresentationFormat>
  <Paragraphs>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Plant &amp; Food Researc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yril brendolise</dc:creator>
  <cp:lastModifiedBy>Andrew Allan</cp:lastModifiedBy>
  <cp:revision>1935</cp:revision>
  <dcterms:created xsi:type="dcterms:W3CDTF">2012-06-06T05:12:53Z</dcterms:created>
  <dcterms:modified xsi:type="dcterms:W3CDTF">2017-09-08T02:42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028C09C9D97D24780058C99077D8847</vt:lpwstr>
  </property>
</Properties>
</file>